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ittlere Formatvorlag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0736" autoAdjust="0"/>
  </p:normalViewPr>
  <p:slideViewPr>
    <p:cSldViewPr>
      <p:cViewPr>
        <p:scale>
          <a:sx n="100" d="100"/>
          <a:sy n="100" d="100"/>
        </p:scale>
        <p:origin x="-2892" y="-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1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/>
          <a:lstStyle>
            <a:lvl1pPr algn="r">
              <a:defRPr sz="1300"/>
            </a:lvl1pPr>
          </a:lstStyle>
          <a:p>
            <a:fld id="{AFF549EC-2D11-46A6-B0A7-ED0A85A81DE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6125"/>
            <a:ext cx="2574925" cy="37226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71" tIns="47786" rIns="95571" bIns="47786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5571" tIns="47786" rIns="95571" bIns="47786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33107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 anchor="b"/>
          <a:lstStyle>
            <a:lvl1pPr algn="r">
              <a:defRPr sz="1300"/>
            </a:lvl1pPr>
          </a:lstStyle>
          <a:p>
            <a:fld id="{5D710603-2D3E-4786-9A44-2160958960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006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710603-2D3E-4786-9A44-2160958960B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1371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963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333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310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574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271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94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064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568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062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702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833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899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5859347"/>
              </p:ext>
            </p:extLst>
          </p:nvPr>
        </p:nvGraphicFramePr>
        <p:xfrm>
          <a:off x="351231" y="1231816"/>
          <a:ext cx="6367971" cy="1742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16455"/>
                <a:gridCol w="610870"/>
                <a:gridCol w="735330"/>
                <a:gridCol w="663131"/>
                <a:gridCol w="1132205"/>
                <a:gridCol w="1109980"/>
              </a:tblGrid>
              <a:tr h="370840"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ictors</a:t>
                      </a:r>
                      <a:endParaRPr lang="en-US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r>
                        <a:rPr lang="de-DE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iction</a:t>
                      </a:r>
                      <a:r>
                        <a:rPr lang="de-D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ININF/total]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b="1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uracy</a:t>
                      </a:r>
                      <a:r>
                        <a:rPr lang="de-DE" sz="12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%]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lang="de-DE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Fadden</a:t>
                      </a:r>
                      <a:r>
                        <a:rPr lang="de-DE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</a:t>
                      </a:r>
                      <a:r>
                        <a:rPr lang="de-DE" sz="1200" b="1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rtile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NINF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INF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/</a:t>
                      </a:r>
                      <a:r>
                        <a:rPr lang="de-DE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ltivation</a:t>
                      </a:r>
                      <a:r>
                        <a:rPr lang="de-D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de-DE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logy</a:t>
                      </a:r>
                      <a:endParaRPr lang="de-D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89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20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/18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2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/</a:t>
                      </a:r>
                      <a:r>
                        <a:rPr lang="de-DE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ltivation</a:t>
                      </a:r>
                      <a:r>
                        <a:rPr lang="de-D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de-DE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logy</a:t>
                      </a:r>
                      <a:r>
                        <a:rPr lang="de-D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</a:p>
                    <a:p>
                      <a:r>
                        <a:rPr lang="de-DE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biome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89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/20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/18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.8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5" name="Rechteck 4"/>
          <p:cNvSpPr/>
          <p:nvPr/>
        </p:nvSpPr>
        <p:spPr>
          <a:xfrm>
            <a:off x="249119" y="344488"/>
            <a:ext cx="642024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Table 3: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edict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agnosi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„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ectiou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ertility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“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nary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ogististic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ositive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diction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ive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ifferent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bination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dictor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ertile,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NINF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INF. Total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curacy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cFadde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</a:t>
            </a:r>
            <a:r>
              <a:rPr lang="de-DE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splaye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3504734"/>
      </p:ext>
    </p:extLst>
  </p:cSld>
  <p:clrMapOvr>
    <a:masterClrMapping/>
  </p:clrMapOvr>
</p:sld>
</file>

<file path=ppt/theme/theme1.xml><?xml version="1.0" encoding="utf-8"?>
<a:theme xmlns:a="http://schemas.openxmlformats.org/drawingml/2006/main" name="Graspeuntner et al_suppl. figures_SG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Graspeuntner et al_suppl. figures_SG</Template>
  <TotalTime>0</TotalTime>
  <Words>75</Words>
  <Application>Microsoft Office PowerPoint</Application>
  <PresentationFormat>A4-Papier (210x297 mm)</PresentationFormat>
  <Paragraphs>23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Graspeuntner et al_suppl. figures_SG</vt:lpstr>
      <vt:lpstr>PowerPoint-Präsentation</vt:lpstr>
    </vt:vector>
  </TitlesOfParts>
  <Company>ITS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Bi, AGRupp</dc:creator>
  <cp:lastModifiedBy>MiBi, AGRupp</cp:lastModifiedBy>
  <cp:revision>7</cp:revision>
  <cp:lastPrinted>2016-02-13T11:55:58Z</cp:lastPrinted>
  <dcterms:created xsi:type="dcterms:W3CDTF">2016-07-21T14:01:48Z</dcterms:created>
  <dcterms:modified xsi:type="dcterms:W3CDTF">2017-08-11T12:10:55Z</dcterms:modified>
</cp:coreProperties>
</file>